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66" r:id="rId3"/>
    <p:sldId id="267" r:id="rId4"/>
    <p:sldId id="265" r:id="rId5"/>
    <p:sldId id="262" r:id="rId6"/>
    <p:sldId id="263" r:id="rId7"/>
    <p:sldId id="257" r:id="rId8"/>
    <p:sldId id="268" r:id="rId9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l D" initials="PCD" lastIdx="1" clrIdx="0">
    <p:extLst>
      <p:ext uri="{19B8F6BF-5375-455C-9EA6-DF929625EA0E}">
        <p15:presenceInfo xmlns:p15="http://schemas.microsoft.com/office/powerpoint/2012/main" userId="Paul 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5214" autoAdjust="0"/>
  </p:normalViewPr>
  <p:slideViewPr>
    <p:cSldViewPr snapToGrid="0">
      <p:cViewPr varScale="1">
        <p:scale>
          <a:sx n="75" d="100"/>
          <a:sy n="75" d="100"/>
        </p:scale>
        <p:origin x="301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193" cy="4974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487" y="0"/>
            <a:ext cx="2950193" cy="4974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0A94D7-5417-432F-AFC3-5C6FAF923110}" type="datetimeFigureOut">
              <a:rPr lang="en-US" smtClean="0"/>
              <a:t>2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1425"/>
            <a:ext cx="2320925" cy="3354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112" y="4783117"/>
            <a:ext cx="5446977" cy="391422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1867"/>
            <a:ext cx="2950193" cy="4974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487" y="9441867"/>
            <a:ext cx="2950193" cy="4974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531C5F-93BA-4B57-AFA3-5A2E98991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493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or (a), I recommend turning “week age” into “age (weeks), and removing the w’s from the x axis, and separating the y in day from the following number by a space (day 0).</a:t>
            </a:r>
          </a:p>
          <a:p>
            <a:r>
              <a:rPr lang="en-US" dirty="0"/>
              <a:t>For (b), you don’t explain “n.d.”, which I imagine means something like “none found”.</a:t>
            </a:r>
          </a:p>
          <a:p>
            <a:r>
              <a:rPr lang="en-US" dirty="0"/>
              <a:t>I think it would be clearer if, at each number on the x axis – days? Why not weeks? – you marked the column positions with A, B, and C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531C5F-93BA-4B57-AFA3-5A2E98991C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367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531C5F-93BA-4B57-AFA3-5A2E98991C6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97099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531C5F-93BA-4B57-AFA3-5A2E98991C6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4323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017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019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37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694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957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567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486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891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07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122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294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1D2D2-ED14-4559-A6CF-581C6D85ACC9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33C5E-7D92-477E-9224-9748D76119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133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C55560A-4FE9-4049-9A9E-4929C03CC35E}"/>
              </a:ext>
            </a:extLst>
          </p:cNvPr>
          <p:cNvSpPr txBox="1"/>
          <p:nvPr/>
        </p:nvSpPr>
        <p:spPr>
          <a:xfrm>
            <a:off x="298138" y="215045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1EB9206-1083-4971-AECC-D01E5E08C651}"/>
              </a:ext>
            </a:extLst>
          </p:cNvPr>
          <p:cNvSpPr txBox="1"/>
          <p:nvPr/>
        </p:nvSpPr>
        <p:spPr>
          <a:xfrm>
            <a:off x="340772" y="877141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.</a:t>
            </a:r>
            <a:endParaRPr kumimoji="1" lang="ja-JP" altLang="en-US" dirty="0"/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C0959AA5-520E-4963-91AF-52BFBE518D5E}"/>
              </a:ext>
            </a:extLst>
          </p:cNvPr>
          <p:cNvGrpSpPr/>
          <p:nvPr/>
        </p:nvGrpSpPr>
        <p:grpSpPr>
          <a:xfrm>
            <a:off x="805004" y="2559236"/>
            <a:ext cx="5635153" cy="1412298"/>
            <a:chOff x="4646200" y="2930423"/>
            <a:chExt cx="6165781" cy="1397489"/>
          </a:xfrm>
        </p:grpSpPr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DDE913C6-3177-4973-83E9-44F4FFA1333D}"/>
                </a:ext>
              </a:extLst>
            </p:cNvPr>
            <p:cNvCxnSpPr>
              <a:cxnSpLocks/>
            </p:cNvCxnSpPr>
            <p:nvPr/>
          </p:nvCxnSpPr>
          <p:spPr>
            <a:xfrm>
              <a:off x="4646200" y="3140424"/>
              <a:ext cx="6165781" cy="694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703553DD-8ABB-4606-B47E-FFE16C503B1C}"/>
                </a:ext>
              </a:extLst>
            </p:cNvPr>
            <p:cNvCxnSpPr/>
            <p:nvPr/>
          </p:nvCxnSpPr>
          <p:spPr>
            <a:xfrm>
              <a:off x="8588900" y="2930423"/>
              <a:ext cx="0" cy="1976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91AFF920-E70F-49E6-BDEF-8629969435B8}"/>
                </a:ext>
              </a:extLst>
            </p:cNvPr>
            <p:cNvCxnSpPr/>
            <p:nvPr/>
          </p:nvCxnSpPr>
          <p:spPr>
            <a:xfrm>
              <a:off x="6891809" y="2940218"/>
              <a:ext cx="0" cy="1976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1C291B4A-2CC0-41BA-A90B-EDA4CE1296A3}"/>
                </a:ext>
              </a:extLst>
            </p:cNvPr>
            <p:cNvCxnSpPr>
              <a:cxnSpLocks/>
            </p:cNvCxnSpPr>
            <p:nvPr/>
          </p:nvCxnSpPr>
          <p:spPr>
            <a:xfrm>
              <a:off x="7731247" y="2940214"/>
              <a:ext cx="0" cy="1976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EED1051-8922-411C-BCCB-0362F7070718}"/>
                </a:ext>
              </a:extLst>
            </p:cNvPr>
            <p:cNvSpPr txBox="1"/>
            <p:nvPr/>
          </p:nvSpPr>
          <p:spPr>
            <a:xfrm>
              <a:off x="5632180" y="3150287"/>
              <a:ext cx="810675" cy="51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ay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0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681CE36D-740C-480D-B3DB-077500D4572E}"/>
                </a:ext>
              </a:extLst>
            </p:cNvPr>
            <p:cNvSpPr txBox="1"/>
            <p:nvPr/>
          </p:nvSpPr>
          <p:spPr>
            <a:xfrm>
              <a:off x="6542306" y="3150287"/>
              <a:ext cx="919420" cy="51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9 </a:t>
              </a:r>
            </a:p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ay 14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0A545AD0-2014-4C4E-B0C1-287A13FF6330}"/>
                </a:ext>
              </a:extLst>
            </p:cNvPr>
            <p:cNvSpPr txBox="1"/>
            <p:nvPr/>
          </p:nvSpPr>
          <p:spPr>
            <a:xfrm>
              <a:off x="7414650" y="3150287"/>
              <a:ext cx="919420" cy="51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ay 28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9596E54-6C97-480B-BF7A-07E694630956}"/>
                </a:ext>
              </a:extLst>
            </p:cNvPr>
            <p:cNvSpPr txBox="1"/>
            <p:nvPr/>
          </p:nvSpPr>
          <p:spPr>
            <a:xfrm>
              <a:off x="8307239" y="3150287"/>
              <a:ext cx="919420" cy="51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ay 42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E9FC4A37-45E6-4309-91B4-91B7135E45F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8635" y="3743908"/>
              <a:ext cx="508674" cy="557598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FE961956-1612-4617-879E-FE49DD06C7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0927" y="3735510"/>
              <a:ext cx="508674" cy="557598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9D797DC4-5CAF-49C6-BB5E-D03C7C7C05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06387" y="3739225"/>
              <a:ext cx="508674" cy="557598"/>
            </a:xfrm>
            <a:prstGeom prst="rect">
              <a:avLst/>
            </a:prstGeom>
          </p:spPr>
        </p:pic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6BA01919-6DFF-4E1D-B0DB-217259289CC5}"/>
                </a:ext>
              </a:extLst>
            </p:cNvPr>
            <p:cNvCxnSpPr/>
            <p:nvPr/>
          </p:nvCxnSpPr>
          <p:spPr>
            <a:xfrm>
              <a:off x="5980651" y="2955904"/>
              <a:ext cx="0" cy="19396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B76FFD41-CF77-4718-811F-C5ABEDBA3B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51848" y="3780670"/>
              <a:ext cx="496415" cy="547242"/>
            </a:xfrm>
            <a:prstGeom prst="rect">
              <a:avLst/>
            </a:prstGeom>
          </p:spPr>
        </p:pic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FB16BC2D-8CD9-4D47-BE0C-88DFBBE651F1}"/>
                </a:ext>
              </a:extLst>
            </p:cNvPr>
            <p:cNvCxnSpPr/>
            <p:nvPr/>
          </p:nvCxnSpPr>
          <p:spPr>
            <a:xfrm>
              <a:off x="9413499" y="2958125"/>
              <a:ext cx="0" cy="1976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AA12E92-6D68-4007-9482-8D3A020E8CFC}"/>
                </a:ext>
              </a:extLst>
            </p:cNvPr>
            <p:cNvSpPr txBox="1"/>
            <p:nvPr/>
          </p:nvSpPr>
          <p:spPr>
            <a:xfrm>
              <a:off x="9141587" y="3150287"/>
              <a:ext cx="919420" cy="51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ay 56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62A45835-7DA4-4089-BB29-E5EC1297DC60}"/>
              </a:ext>
            </a:extLst>
          </p:cNvPr>
          <p:cNvCxnSpPr>
            <a:cxnSpLocks/>
          </p:cNvCxnSpPr>
          <p:nvPr/>
        </p:nvCxnSpPr>
        <p:spPr>
          <a:xfrm>
            <a:off x="2024612" y="2071948"/>
            <a:ext cx="0" cy="39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6BA8937-FCA9-43D3-A5EA-E6E2C3620BD6}"/>
              </a:ext>
            </a:extLst>
          </p:cNvPr>
          <p:cNvSpPr txBox="1"/>
          <p:nvPr/>
        </p:nvSpPr>
        <p:spPr>
          <a:xfrm>
            <a:off x="961014" y="1466422"/>
            <a:ext cx="9012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lood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mplin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涙形 41">
            <a:extLst>
              <a:ext uri="{FF2B5EF4-FFF2-40B4-BE49-F238E27FC236}">
                <a16:creationId xmlns:a16="http://schemas.microsoft.com/office/drawing/2014/main" id="{9162D52B-4FEC-4396-BD80-6DEDC0E9BD21}"/>
              </a:ext>
            </a:extLst>
          </p:cNvPr>
          <p:cNvSpPr/>
          <p:nvPr/>
        </p:nvSpPr>
        <p:spPr>
          <a:xfrm rot="18657911">
            <a:off x="1886839" y="1598931"/>
            <a:ext cx="329796" cy="315912"/>
          </a:xfrm>
          <a:prstGeom prst="teardrop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6943FDEB-7CAC-4594-A0FC-1BB82133B24E}"/>
              </a:ext>
            </a:extLst>
          </p:cNvPr>
          <p:cNvCxnSpPr>
            <a:cxnSpLocks/>
          </p:cNvCxnSpPr>
          <p:nvPr/>
        </p:nvCxnSpPr>
        <p:spPr>
          <a:xfrm>
            <a:off x="2859030" y="2071948"/>
            <a:ext cx="0" cy="39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涙形 43">
            <a:extLst>
              <a:ext uri="{FF2B5EF4-FFF2-40B4-BE49-F238E27FC236}">
                <a16:creationId xmlns:a16="http://schemas.microsoft.com/office/drawing/2014/main" id="{2B9B9620-F5FC-408D-A0A3-E57AAE4926F7}"/>
              </a:ext>
            </a:extLst>
          </p:cNvPr>
          <p:cNvSpPr/>
          <p:nvPr/>
        </p:nvSpPr>
        <p:spPr>
          <a:xfrm rot="18657911">
            <a:off x="2669771" y="1598931"/>
            <a:ext cx="329796" cy="315912"/>
          </a:xfrm>
          <a:prstGeom prst="teardrop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5840AC41-6499-47A6-BBAC-AB8415259C03}"/>
              </a:ext>
            </a:extLst>
          </p:cNvPr>
          <p:cNvCxnSpPr>
            <a:cxnSpLocks/>
          </p:cNvCxnSpPr>
          <p:nvPr/>
        </p:nvCxnSpPr>
        <p:spPr>
          <a:xfrm>
            <a:off x="3642795" y="2071948"/>
            <a:ext cx="0" cy="39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涙形 45">
            <a:extLst>
              <a:ext uri="{FF2B5EF4-FFF2-40B4-BE49-F238E27FC236}">
                <a16:creationId xmlns:a16="http://schemas.microsoft.com/office/drawing/2014/main" id="{82906132-EF73-4484-99AF-DD60E293F9BD}"/>
              </a:ext>
            </a:extLst>
          </p:cNvPr>
          <p:cNvSpPr/>
          <p:nvPr/>
        </p:nvSpPr>
        <p:spPr>
          <a:xfrm rot="18657911">
            <a:off x="3452703" y="1598931"/>
            <a:ext cx="329796" cy="315912"/>
          </a:xfrm>
          <a:prstGeom prst="teardrop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C4346753-C37B-41E8-A1B2-B93F2D455359}"/>
              </a:ext>
            </a:extLst>
          </p:cNvPr>
          <p:cNvCxnSpPr>
            <a:cxnSpLocks/>
          </p:cNvCxnSpPr>
          <p:nvPr/>
        </p:nvCxnSpPr>
        <p:spPr>
          <a:xfrm>
            <a:off x="4429239" y="2071948"/>
            <a:ext cx="0" cy="39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涙形 47">
            <a:extLst>
              <a:ext uri="{FF2B5EF4-FFF2-40B4-BE49-F238E27FC236}">
                <a16:creationId xmlns:a16="http://schemas.microsoft.com/office/drawing/2014/main" id="{1C989DF0-11B8-4246-9D0B-A23EB175DA00}"/>
              </a:ext>
            </a:extLst>
          </p:cNvPr>
          <p:cNvSpPr/>
          <p:nvPr/>
        </p:nvSpPr>
        <p:spPr>
          <a:xfrm rot="18657911">
            <a:off x="4235635" y="1598931"/>
            <a:ext cx="329796" cy="315912"/>
          </a:xfrm>
          <a:prstGeom prst="teardrop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51CD05CB-4D31-4945-8C3A-9C19509C1E13}"/>
              </a:ext>
            </a:extLst>
          </p:cNvPr>
          <p:cNvCxnSpPr>
            <a:cxnSpLocks/>
          </p:cNvCxnSpPr>
          <p:nvPr/>
        </p:nvCxnSpPr>
        <p:spPr>
          <a:xfrm>
            <a:off x="5156340" y="2071948"/>
            <a:ext cx="0" cy="39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涙形 49">
            <a:extLst>
              <a:ext uri="{FF2B5EF4-FFF2-40B4-BE49-F238E27FC236}">
                <a16:creationId xmlns:a16="http://schemas.microsoft.com/office/drawing/2014/main" id="{A5E85DA7-A237-42DB-A579-F4D64D3BAC7D}"/>
              </a:ext>
            </a:extLst>
          </p:cNvPr>
          <p:cNvSpPr/>
          <p:nvPr/>
        </p:nvSpPr>
        <p:spPr>
          <a:xfrm rot="18657911">
            <a:off x="5018567" y="1598931"/>
            <a:ext cx="329796" cy="315912"/>
          </a:xfrm>
          <a:prstGeom prst="teardrop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B7E2A7-88A4-4583-8397-5A26297A6BDC}"/>
              </a:ext>
            </a:extLst>
          </p:cNvPr>
          <p:cNvSpPr txBox="1"/>
          <p:nvPr/>
        </p:nvSpPr>
        <p:spPr>
          <a:xfrm>
            <a:off x="3969775" y="3561807"/>
            <a:ext cx="10978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accinatio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180E429-1CFC-4AA0-B275-C769965578CE}"/>
              </a:ext>
            </a:extLst>
          </p:cNvPr>
          <p:cNvSpPr txBox="1"/>
          <p:nvPr/>
        </p:nvSpPr>
        <p:spPr>
          <a:xfrm>
            <a:off x="5524518" y="2808930"/>
            <a:ext cx="8077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B241017-EC16-47F2-81D6-C7F05D630E7F}"/>
              </a:ext>
            </a:extLst>
          </p:cNvPr>
          <p:cNvSpPr txBox="1"/>
          <p:nvPr/>
        </p:nvSpPr>
        <p:spPr>
          <a:xfrm rot="16200000">
            <a:off x="-439440" y="4681452"/>
            <a:ext cx="2969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dirty="0"/>
              <a:t>ELISA titer, OD50%</a:t>
            </a:r>
            <a:endParaRPr kumimoji="1" lang="ja-JP" altLang="en-US" sz="18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28F7AF9-33ED-4781-8DAF-E5258613A1A8}"/>
              </a:ext>
            </a:extLst>
          </p:cNvPr>
          <p:cNvSpPr txBox="1"/>
          <p:nvPr/>
        </p:nvSpPr>
        <p:spPr>
          <a:xfrm>
            <a:off x="28766" y="7764977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E31D575-960A-4789-8CF5-63F27D850718}"/>
              </a:ext>
            </a:extLst>
          </p:cNvPr>
          <p:cNvSpPr txBox="1"/>
          <p:nvPr/>
        </p:nvSpPr>
        <p:spPr>
          <a:xfrm>
            <a:off x="115449" y="8163585"/>
            <a:ext cx="6792244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 The three peptide vaccines were conjugated to KLH and co-administere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with the Freund’s adjuvant to seven-week-old male C57BL/6NCrslc mice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four times at two-week intervals.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 Evaluation of antibody production by the enzyme-linked immunosorbent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ssay (ELISA) showed that the titer against antigen peptide was successfully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creased on day 42 and 56 in mice immunized with #A, on day 56 with #B vaccine.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 antibody was detected in mouse serum immunized by vaccine #C.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763890D2-180C-43A1-B0CD-5E571D62B1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393" y="4277568"/>
            <a:ext cx="6492803" cy="3517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1772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3EC241-D5CF-4716-9915-A677270482F5}"/>
              </a:ext>
            </a:extLst>
          </p:cNvPr>
          <p:cNvSpPr txBox="1"/>
          <p:nvPr/>
        </p:nvSpPr>
        <p:spPr>
          <a:xfrm>
            <a:off x="325676" y="225468"/>
            <a:ext cx="2806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52807EF-5462-46B4-A78A-5170F3E3CFDA}"/>
              </a:ext>
            </a:extLst>
          </p:cNvPr>
          <p:cNvSpPr txBox="1"/>
          <p:nvPr/>
        </p:nvSpPr>
        <p:spPr>
          <a:xfrm rot="16200000">
            <a:off x="772141" y="2340150"/>
            <a:ext cx="2754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,15-EET-d11/14,15-DHET-d1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0FDE3D4-B3AC-440D-90C6-CD4446A47278}"/>
              </a:ext>
            </a:extLst>
          </p:cNvPr>
          <p:cNvSpPr txBox="1"/>
          <p:nvPr/>
        </p:nvSpPr>
        <p:spPr>
          <a:xfrm>
            <a:off x="34510" y="6713602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2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D50A5F8-7C78-435B-9A70-B3E396A3E388}"/>
              </a:ext>
            </a:extLst>
          </p:cNvPr>
          <p:cNvSpPr txBox="1"/>
          <p:nvPr/>
        </p:nvSpPr>
        <p:spPr>
          <a:xfrm>
            <a:off x="213367" y="7194500"/>
            <a:ext cx="621059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The </a:t>
            </a:r>
            <a:r>
              <a:rPr lang="en-US" altLang="ja-JP" sz="1400" kern="100" dirty="0" err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eptode</a:t>
            </a:r>
            <a:r>
              <a:rPr lang="en-US" altLang="ja-JP" sz="14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B vaccine did not induce neutralize antibody.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blood was collected at 14 weeks of age in all rats and analyzed. The antibody in blood did not prevent 14,15-EET-d11 from being hydrolyzed into 14,15-DHET-d11, and the ratio of 14,15-EET-d11 to 14,15-DHET-d11 was unchanged in the vaccinated group. n = 4 in each group.(b) Representative image of short axis section of infarcted hearts at day7 after LAD ligation. Scale bar; 2.5mm </a:t>
            </a:r>
          </a:p>
          <a:p>
            <a:r>
              <a:rPr lang="en-US" altLang="ja-JP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arcted area/left </a:t>
            </a:r>
            <a:r>
              <a:rPr lang="en-US" altLang="ja-JP" sz="1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mtricular</a:t>
            </a:r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rea were measured from photo  of Azan staining by </a:t>
            </a:r>
            <a:r>
              <a:rPr lang="en-US" altLang="ja-JP" sz="1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ageJ</a:t>
            </a:r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calculated. There are no effect of reducing infarcted area by peptide B vaccine.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D4BEA2F-93D8-40C5-A524-A0AD2D404771}"/>
              </a:ext>
            </a:extLst>
          </p:cNvPr>
          <p:cNvSpPr txBox="1"/>
          <p:nvPr/>
        </p:nvSpPr>
        <p:spPr>
          <a:xfrm>
            <a:off x="1872647" y="74753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D55D57C-0D2C-4BD3-B81A-332954F84C89}"/>
              </a:ext>
            </a:extLst>
          </p:cNvPr>
          <p:cNvSpPr txBox="1"/>
          <p:nvPr/>
        </p:nvSpPr>
        <p:spPr>
          <a:xfrm>
            <a:off x="92587" y="403753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4A00900-0386-4F7B-9526-270DC4BCB861}"/>
              </a:ext>
            </a:extLst>
          </p:cNvPr>
          <p:cNvSpPr txBox="1"/>
          <p:nvPr/>
        </p:nvSpPr>
        <p:spPr>
          <a:xfrm>
            <a:off x="569973" y="46228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80B5B22-A4D5-484D-91E4-57DEA06F9298}"/>
              </a:ext>
            </a:extLst>
          </p:cNvPr>
          <p:cNvSpPr txBox="1"/>
          <p:nvPr/>
        </p:nvSpPr>
        <p:spPr>
          <a:xfrm rot="16200000">
            <a:off x="1431113" y="3692886"/>
            <a:ext cx="5061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farcted area/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eft ventricular area  (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％）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FC5C83-8EEF-4752-90CB-60D8BC9070F2}"/>
              </a:ext>
            </a:extLst>
          </p:cNvPr>
          <p:cNvSpPr txBox="1"/>
          <p:nvPr/>
        </p:nvSpPr>
        <p:spPr>
          <a:xfrm>
            <a:off x="596293" y="5804308"/>
            <a:ext cx="10498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aline </a:t>
            </a:r>
            <a:r>
              <a:rPr kumimoji="1" lang="ja-JP" altLang="en-US" dirty="0"/>
              <a:t>∔</a:t>
            </a:r>
            <a:r>
              <a:rPr kumimoji="1" lang="en-US" altLang="ja-JP" dirty="0"/>
              <a:t>MI</a:t>
            </a:r>
            <a:endParaRPr kumimoji="1" lang="ja-JP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6E9D199-6EFC-4350-AAC2-7C485BA869BB}"/>
              </a:ext>
            </a:extLst>
          </p:cNvPr>
          <p:cNvSpPr txBox="1"/>
          <p:nvPr/>
        </p:nvSpPr>
        <p:spPr>
          <a:xfrm>
            <a:off x="1936695" y="5777784"/>
            <a:ext cx="15752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PeptideB</a:t>
            </a:r>
            <a:r>
              <a:rPr kumimoji="1" lang="en-US" altLang="ja-JP" dirty="0"/>
              <a:t> vaccine </a:t>
            </a:r>
            <a:r>
              <a:rPr kumimoji="1" lang="ja-JP" altLang="en-US" dirty="0"/>
              <a:t>∔</a:t>
            </a:r>
            <a:r>
              <a:rPr kumimoji="1" lang="en-US" altLang="ja-JP" dirty="0"/>
              <a:t>MI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0B47320-1CE0-4F46-9BBE-0E082ACE2E16}"/>
              </a:ext>
            </a:extLst>
          </p:cNvPr>
          <p:cNvGrpSpPr/>
          <p:nvPr/>
        </p:nvGrpSpPr>
        <p:grpSpPr>
          <a:xfrm>
            <a:off x="461827" y="4274382"/>
            <a:ext cx="3042815" cy="1372426"/>
            <a:chOff x="461827" y="4274382"/>
            <a:chExt cx="3042815" cy="1372426"/>
          </a:xfrm>
        </p:grpSpPr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ED5B928E-36BC-4B7C-B491-DAABEECC78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334" t="3278" r="18778" b="532"/>
            <a:stretch/>
          </p:blipFill>
          <p:spPr>
            <a:xfrm>
              <a:off x="2017160" y="4289572"/>
              <a:ext cx="1487482" cy="1357236"/>
            </a:xfrm>
            <a:prstGeom prst="rect">
              <a:avLst/>
            </a:prstGeom>
          </p:spPr>
        </p:pic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AD570BF9-98FF-4200-A1A1-567DEB5A7BA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1827" y="4274382"/>
              <a:ext cx="1443955" cy="1357236"/>
              <a:chOff x="-3863450" y="1963714"/>
              <a:chExt cx="4489376" cy="4219758"/>
            </a:xfrm>
          </p:grpSpPr>
          <p:pic>
            <p:nvPicPr>
              <p:cNvPr id="26" name="図 25" descr="図形 が含まれている画像&#10;&#10;自動的に生成された説明">
                <a:extLst>
                  <a:ext uri="{FF2B5EF4-FFF2-40B4-BE49-F238E27FC236}">
                    <a16:creationId xmlns:a16="http://schemas.microsoft.com/office/drawing/2014/main" id="{6004AA13-DE39-45EB-84C0-5844D5A427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27" t="1085" r="18910" b="467"/>
              <a:stretch/>
            </p:blipFill>
            <p:spPr>
              <a:xfrm>
                <a:off x="-3863450" y="1963714"/>
                <a:ext cx="4489376" cy="4219758"/>
              </a:xfrm>
              <a:prstGeom prst="rect">
                <a:avLst/>
              </a:prstGeom>
            </p:spPr>
          </p:pic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07D2F40E-8F1A-40B3-A103-E3E5A3CDA3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052168" y="5574400"/>
                <a:ext cx="105216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D30E7465-DC74-45C3-B9AA-65F63446ABA2}"/>
                </a:ext>
              </a:extLst>
            </p:cNvPr>
            <p:cNvCxnSpPr>
              <a:cxnSpLocks/>
            </p:cNvCxnSpPr>
            <p:nvPr/>
          </p:nvCxnSpPr>
          <p:spPr>
            <a:xfrm>
              <a:off x="3058218" y="5324077"/>
              <a:ext cx="33841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図 1">
            <a:extLst>
              <a:ext uri="{FF2B5EF4-FFF2-40B4-BE49-F238E27FC236}">
                <a16:creationId xmlns:a16="http://schemas.microsoft.com/office/drawing/2014/main" id="{55E98CE2-1B5D-4CEF-A378-A6CC9C6E67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5979" y="1423567"/>
            <a:ext cx="2810500" cy="238983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4ED2E35-9201-4E9E-90E1-C3FABF72D35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00488" y="4222200"/>
            <a:ext cx="2542252" cy="2426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2607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 descr="コンピューターの画面&#10;&#10;自動的に生成された説明">
            <a:extLst>
              <a:ext uri="{FF2B5EF4-FFF2-40B4-BE49-F238E27FC236}">
                <a16:creationId xmlns:a16="http://schemas.microsoft.com/office/drawing/2014/main" id="{ABFC66E6-86FB-42F0-84E2-36D0B5AD31B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722" r="46652"/>
          <a:stretch/>
        </p:blipFill>
        <p:spPr>
          <a:xfrm>
            <a:off x="100864" y="771410"/>
            <a:ext cx="3162000" cy="244534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1662E2D-D2AB-425C-BF47-0B5B428B0C9C}"/>
              </a:ext>
            </a:extLst>
          </p:cNvPr>
          <p:cNvSpPr txBox="1"/>
          <p:nvPr/>
        </p:nvSpPr>
        <p:spPr>
          <a:xfrm>
            <a:off x="38513" y="-84538"/>
            <a:ext cx="2806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E44ABD55-4092-49D9-B5B8-870FCCABCB5A}"/>
              </a:ext>
            </a:extLst>
          </p:cNvPr>
          <p:cNvGrpSpPr/>
          <p:nvPr/>
        </p:nvGrpSpPr>
        <p:grpSpPr>
          <a:xfrm>
            <a:off x="548640" y="5131112"/>
            <a:ext cx="5509260" cy="1631216"/>
            <a:chOff x="548640" y="840444"/>
            <a:chExt cx="5509260" cy="1631216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DD3C55F-E86D-497B-B399-7415715605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4000" t="45353" r="7444" b="46746"/>
            <a:stretch/>
          </p:blipFill>
          <p:spPr>
            <a:xfrm>
              <a:off x="1287780" y="1283732"/>
              <a:ext cx="4770120" cy="309246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E7C1ED84-1A1E-485F-8D34-899724712D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7503" t="51670" r="12941" b="40442"/>
            <a:stretch/>
          </p:blipFill>
          <p:spPr>
            <a:xfrm>
              <a:off x="1287780" y="859256"/>
              <a:ext cx="4770120" cy="304800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7A294732-F806-4BB9-90BF-797D2A0E33F3}"/>
                </a:ext>
              </a:extLst>
            </p:cNvPr>
            <p:cNvSpPr txBox="1"/>
            <p:nvPr/>
          </p:nvSpPr>
          <p:spPr>
            <a:xfrm>
              <a:off x="548640" y="1209776"/>
              <a:ext cx="644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actin</a:t>
              </a:r>
              <a:endParaRPr kumimoji="1" lang="ja-JP" altLang="en-US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44ECC92-29DC-4CFB-8934-1FA7DAE09B99}"/>
                </a:ext>
              </a:extLst>
            </p:cNvPr>
            <p:cNvSpPr txBox="1"/>
            <p:nvPr/>
          </p:nvSpPr>
          <p:spPr>
            <a:xfrm>
              <a:off x="557185" y="840444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sEH</a:t>
              </a:r>
              <a:endParaRPr kumimoji="1" lang="ja-JP" altLang="en-US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EB5476C-2270-496B-ACE4-B26B773FFDFB}"/>
                </a:ext>
              </a:extLst>
            </p:cNvPr>
            <p:cNvSpPr txBox="1"/>
            <p:nvPr/>
          </p:nvSpPr>
          <p:spPr>
            <a:xfrm>
              <a:off x="564805" y="1948440"/>
              <a:ext cx="217953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A:Infarcted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area, </a:t>
              </a:r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I:Non-infarcted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are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78D98F6-AEF2-40A5-99F9-915E01A60492}"/>
                </a:ext>
              </a:extLst>
            </p:cNvPr>
            <p:cNvSpPr txBox="1"/>
            <p:nvPr/>
          </p:nvSpPr>
          <p:spPr>
            <a:xfrm>
              <a:off x="1370714" y="1595675"/>
              <a:ext cx="793366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A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2554A365-C008-4AE7-A233-7A6C5F5D4E42}"/>
                </a:ext>
              </a:extLst>
            </p:cNvPr>
            <p:cNvSpPr txBox="1"/>
            <p:nvPr/>
          </p:nvSpPr>
          <p:spPr>
            <a:xfrm>
              <a:off x="2164080" y="1595675"/>
              <a:ext cx="793366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A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7A74CC1D-A51E-4B84-82BB-BE74CA8499C8}"/>
                </a:ext>
              </a:extLst>
            </p:cNvPr>
            <p:cNvSpPr txBox="1"/>
            <p:nvPr/>
          </p:nvSpPr>
          <p:spPr>
            <a:xfrm>
              <a:off x="3241867" y="1595675"/>
              <a:ext cx="793366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A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21F08DDF-AD82-45B7-BCED-6E3726B9618A}"/>
                </a:ext>
              </a:extLst>
            </p:cNvPr>
            <p:cNvSpPr txBox="1"/>
            <p:nvPr/>
          </p:nvSpPr>
          <p:spPr>
            <a:xfrm>
              <a:off x="3984374" y="1595675"/>
              <a:ext cx="793366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A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3C95484-ED03-4D7F-9768-EE3A643CC0BE}"/>
                </a:ext>
              </a:extLst>
            </p:cNvPr>
            <p:cNvSpPr txBox="1"/>
            <p:nvPr/>
          </p:nvSpPr>
          <p:spPr>
            <a:xfrm>
              <a:off x="5074034" y="1595675"/>
              <a:ext cx="793366" cy="3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A</a:t>
              </a:r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C5B64DA-B945-441A-B839-7CC9005896A7}"/>
              </a:ext>
            </a:extLst>
          </p:cNvPr>
          <p:cNvSpPr txBox="1"/>
          <p:nvPr/>
        </p:nvSpPr>
        <p:spPr>
          <a:xfrm>
            <a:off x="157041" y="6906004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DFD82DC-196B-4EF8-BDAE-2FE101B3F366}"/>
              </a:ext>
            </a:extLst>
          </p:cNvPr>
          <p:cNvSpPr txBox="1"/>
          <p:nvPr/>
        </p:nvSpPr>
        <p:spPr>
          <a:xfrm>
            <a:off x="134547" y="7276459"/>
            <a:ext cx="628183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protein expressed in the cardiac muscle but not in the fibrotic infarcted area.(a) The border zone of the infarcted cardiac muscle was evaluated for existence of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in the heart.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was abundantly stained by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luorescent immunostaining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1:200,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roteintec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,#10833-1 AP, Red, arrowhead) in the cardiomyocytes but not in the fibrotic area including cardiac fibroblasts. The nuclei were stained with Hoechst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3342 (blue).(b) Infarcted area of cardiac muscle was separated from non-infarcted area and performed western blotting. The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expression was markedly reduced in the infarcted area.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09114AF-A0A1-46DA-A91F-D6794E2B80A5}"/>
              </a:ext>
            </a:extLst>
          </p:cNvPr>
          <p:cNvSpPr txBox="1"/>
          <p:nvPr/>
        </p:nvSpPr>
        <p:spPr>
          <a:xfrm>
            <a:off x="42459" y="31931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A380B4E-E1BB-4C0D-8BCD-538EC6AD360A}"/>
              </a:ext>
            </a:extLst>
          </p:cNvPr>
          <p:cNvSpPr txBox="1"/>
          <p:nvPr/>
        </p:nvSpPr>
        <p:spPr>
          <a:xfrm>
            <a:off x="49593" y="3249899"/>
            <a:ext cx="25571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d: anti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ntibody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lue: nucleu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E48A472-387E-449B-B7A6-18EB237E6F14}"/>
              </a:ext>
            </a:extLst>
          </p:cNvPr>
          <p:cNvSpPr txBox="1"/>
          <p:nvPr/>
        </p:nvSpPr>
        <p:spPr>
          <a:xfrm>
            <a:off x="1807852" y="2919053"/>
            <a:ext cx="1870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arcted area 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6FCD129-A7AD-4CD9-8EDD-C13A2AED920F}"/>
              </a:ext>
            </a:extLst>
          </p:cNvPr>
          <p:cNvSpPr txBox="1"/>
          <p:nvPr/>
        </p:nvSpPr>
        <p:spPr>
          <a:xfrm>
            <a:off x="115607" y="932893"/>
            <a:ext cx="1870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infarcted area 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図 33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4D51C669-508C-40C6-A6ED-4F2D7D2C639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701" t="66151" r="840" b="3141"/>
          <a:stretch/>
        </p:blipFill>
        <p:spPr>
          <a:xfrm>
            <a:off x="3747247" y="815646"/>
            <a:ext cx="2161970" cy="2418038"/>
          </a:xfrm>
          <a:prstGeom prst="rect">
            <a:avLst/>
          </a:prstGeom>
        </p:spPr>
      </p:pic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8D5E8B8C-560B-4615-921F-98A25B0877AF}"/>
              </a:ext>
            </a:extLst>
          </p:cNvPr>
          <p:cNvCxnSpPr>
            <a:cxnSpLocks/>
          </p:cNvCxnSpPr>
          <p:nvPr/>
        </p:nvCxnSpPr>
        <p:spPr>
          <a:xfrm flipH="1" flipV="1">
            <a:off x="3262864" y="771410"/>
            <a:ext cx="823179" cy="9563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5BBE93EE-B8B1-46FE-ABCC-D1CA0456397B}"/>
              </a:ext>
            </a:extLst>
          </p:cNvPr>
          <p:cNvCxnSpPr>
            <a:cxnSpLocks/>
          </p:cNvCxnSpPr>
          <p:nvPr/>
        </p:nvCxnSpPr>
        <p:spPr>
          <a:xfrm flipH="1">
            <a:off x="3263188" y="1847454"/>
            <a:ext cx="822854" cy="13485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矢印: 右 52">
            <a:extLst>
              <a:ext uri="{FF2B5EF4-FFF2-40B4-BE49-F238E27FC236}">
                <a16:creationId xmlns:a16="http://schemas.microsoft.com/office/drawing/2014/main" id="{0BDE0392-6BBC-4AB1-A697-9B77F2861865}"/>
              </a:ext>
            </a:extLst>
          </p:cNvPr>
          <p:cNvSpPr/>
          <p:nvPr/>
        </p:nvSpPr>
        <p:spPr>
          <a:xfrm rot="18194105">
            <a:off x="2218924" y="1146749"/>
            <a:ext cx="168384" cy="124690"/>
          </a:xfrm>
          <a:prstGeom prst="rightArrow">
            <a:avLst>
              <a:gd name="adj1" fmla="val 50000"/>
              <a:gd name="adj2" fmla="val 205281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矢印: 右 53">
            <a:extLst>
              <a:ext uri="{FF2B5EF4-FFF2-40B4-BE49-F238E27FC236}">
                <a16:creationId xmlns:a16="http://schemas.microsoft.com/office/drawing/2014/main" id="{A1C91D9A-5A90-4E41-8ABF-DA11BA64BDD8}"/>
              </a:ext>
            </a:extLst>
          </p:cNvPr>
          <p:cNvSpPr/>
          <p:nvPr/>
        </p:nvSpPr>
        <p:spPr>
          <a:xfrm rot="18194105">
            <a:off x="376599" y="1634162"/>
            <a:ext cx="168384" cy="124690"/>
          </a:xfrm>
          <a:prstGeom prst="rightArrow">
            <a:avLst>
              <a:gd name="adj1" fmla="val 50000"/>
              <a:gd name="adj2" fmla="val 205281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矢印: 右 54">
            <a:extLst>
              <a:ext uri="{FF2B5EF4-FFF2-40B4-BE49-F238E27FC236}">
                <a16:creationId xmlns:a16="http://schemas.microsoft.com/office/drawing/2014/main" id="{81FEBB78-6A5E-4DAD-A440-71D5B71D6931}"/>
              </a:ext>
            </a:extLst>
          </p:cNvPr>
          <p:cNvSpPr/>
          <p:nvPr/>
        </p:nvSpPr>
        <p:spPr>
          <a:xfrm rot="18194105">
            <a:off x="1003908" y="1685323"/>
            <a:ext cx="168384" cy="124690"/>
          </a:xfrm>
          <a:prstGeom prst="rightArrow">
            <a:avLst>
              <a:gd name="adj1" fmla="val 50000"/>
              <a:gd name="adj2" fmla="val 205281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矢印: 右 55">
            <a:extLst>
              <a:ext uri="{FF2B5EF4-FFF2-40B4-BE49-F238E27FC236}">
                <a16:creationId xmlns:a16="http://schemas.microsoft.com/office/drawing/2014/main" id="{07F05B27-5C67-4D1D-B679-673340B87DC2}"/>
              </a:ext>
            </a:extLst>
          </p:cNvPr>
          <p:cNvSpPr/>
          <p:nvPr/>
        </p:nvSpPr>
        <p:spPr>
          <a:xfrm rot="18194105">
            <a:off x="1485054" y="1476142"/>
            <a:ext cx="168384" cy="124690"/>
          </a:xfrm>
          <a:prstGeom prst="rightArrow">
            <a:avLst>
              <a:gd name="adj1" fmla="val 50000"/>
              <a:gd name="adj2" fmla="val 205281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矢印: 右 56">
            <a:extLst>
              <a:ext uri="{FF2B5EF4-FFF2-40B4-BE49-F238E27FC236}">
                <a16:creationId xmlns:a16="http://schemas.microsoft.com/office/drawing/2014/main" id="{AC85A551-BDCE-44F5-9823-6A0673ED4D50}"/>
              </a:ext>
            </a:extLst>
          </p:cNvPr>
          <p:cNvSpPr/>
          <p:nvPr/>
        </p:nvSpPr>
        <p:spPr>
          <a:xfrm rot="18194105">
            <a:off x="2415506" y="1898588"/>
            <a:ext cx="168384" cy="124690"/>
          </a:xfrm>
          <a:prstGeom prst="rightArrow">
            <a:avLst>
              <a:gd name="adj1" fmla="val 50000"/>
              <a:gd name="adj2" fmla="val 205281"/>
            </a:avLst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086B86D4-68AD-4EC6-BC03-DBB2D7CC7306}"/>
              </a:ext>
            </a:extLst>
          </p:cNvPr>
          <p:cNvSpPr txBox="1"/>
          <p:nvPr/>
        </p:nvSpPr>
        <p:spPr>
          <a:xfrm>
            <a:off x="115607" y="481623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55857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7C9BAF3-DD2C-4E8E-BCBD-7BFF2B933C99}"/>
              </a:ext>
            </a:extLst>
          </p:cNvPr>
          <p:cNvSpPr txBox="1"/>
          <p:nvPr/>
        </p:nvSpPr>
        <p:spPr>
          <a:xfrm>
            <a:off x="325676" y="225468"/>
            <a:ext cx="3281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02E731B-6B13-461A-B63A-165033AF4412}"/>
              </a:ext>
            </a:extLst>
          </p:cNvPr>
          <p:cNvSpPr txBox="1"/>
          <p:nvPr/>
        </p:nvSpPr>
        <p:spPr>
          <a:xfrm rot="16200000">
            <a:off x="-837270" y="2138875"/>
            <a:ext cx="34976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4,15-EET-d11/14,15-DHET-d11</a:t>
            </a:r>
          </a:p>
          <a:p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DE63F54-696C-4855-966B-51CD9761041C}"/>
              </a:ext>
            </a:extLst>
          </p:cNvPr>
          <p:cNvSpPr txBox="1"/>
          <p:nvPr/>
        </p:nvSpPr>
        <p:spPr>
          <a:xfrm>
            <a:off x="82581" y="4793056"/>
            <a:ext cx="20903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 figure 4</a:t>
            </a:r>
          </a:p>
          <a:p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DBB758-B983-4DDA-B6DF-B29C9E1586C5}"/>
              </a:ext>
            </a:extLst>
          </p:cNvPr>
          <p:cNvSpPr txBox="1"/>
          <p:nvPr/>
        </p:nvSpPr>
        <p:spPr>
          <a:xfrm>
            <a:off x="0" y="5211494"/>
            <a:ext cx="7022243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,15-EET-d11 hydrolyzation was enhanced in the blood after LAD ligation. The blood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as collected from rat tail before and 4hr after from the LAD ligation. </a:t>
            </a:r>
            <a:r>
              <a:rPr kumimoji="1"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g/</a:t>
            </a:r>
            <a:r>
              <a:rPr kumimoji="1"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,15-EET-d1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ded in the collected blood and incubated 15min at 37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℃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atio of 14,15-EET-d11/14,15-DHET-d11 were significantly decreased in blood at 4hr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fter LAD ligation. It is suggested myocardial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H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was released into blood after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yocardial infarction. N=6 in each group. *P &lt; 0.05. 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217660B-B8CF-4E67-A29B-F071B9859C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2802" y="1179111"/>
            <a:ext cx="4572396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4678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60A1A56-D75F-48B3-A0AB-6FE7B88C37A9}"/>
              </a:ext>
            </a:extLst>
          </p:cNvPr>
          <p:cNvGrpSpPr/>
          <p:nvPr/>
        </p:nvGrpSpPr>
        <p:grpSpPr>
          <a:xfrm>
            <a:off x="-22365" y="837926"/>
            <a:ext cx="6858000" cy="3857625"/>
            <a:chOff x="0" y="3040610"/>
            <a:chExt cx="6858000" cy="3857625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040610"/>
              <a:ext cx="6858000" cy="3857625"/>
            </a:xfrm>
            <a:prstGeom prst="rect">
              <a:avLst/>
            </a:prstGeom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1224644" y="3682543"/>
              <a:ext cx="5008789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/>
                <a:t>Rat</a:t>
              </a:r>
              <a:r>
                <a:rPr kumimoji="1" lang="ja-JP" altLang="en-US" sz="1350" dirty="0"/>
                <a:t>　　</a:t>
              </a:r>
              <a:r>
                <a:rPr kumimoji="1" lang="en-US" altLang="ja-JP" sz="1350" dirty="0"/>
                <a:t>VEGF</a:t>
              </a:r>
              <a:r>
                <a:rPr kumimoji="1" lang="ja-JP" altLang="en-US" sz="1350" dirty="0"/>
                <a:t>　</a:t>
              </a: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683885" y="5776254"/>
              <a:ext cx="891675" cy="189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19" dirty="0"/>
                <a:t>Saline              Vaccine     </a:t>
              </a:r>
              <a:endParaRPr kumimoji="1" lang="ja-JP" altLang="en-US" sz="619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175657" y="4621195"/>
              <a:ext cx="587829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13" dirty="0"/>
                <a:t>50</a:t>
              </a:r>
              <a:r>
                <a:rPr kumimoji="1" lang="ja-JP" altLang="en-US" sz="1013" dirty="0" err="1"/>
                <a:t>ｋ</a:t>
              </a:r>
              <a:r>
                <a:rPr kumimoji="1" lang="en-US" altLang="ja-JP" sz="1013" dirty="0"/>
                <a:t>Da</a:t>
              </a:r>
              <a:endParaRPr kumimoji="1" lang="ja-JP" altLang="en-US" sz="1013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175657" y="4865548"/>
              <a:ext cx="820511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13" dirty="0"/>
                <a:t>37</a:t>
              </a:r>
              <a:r>
                <a:rPr kumimoji="1" lang="ja-JP" altLang="en-US" sz="1013" dirty="0" err="1"/>
                <a:t>ｋ</a:t>
              </a:r>
              <a:r>
                <a:rPr kumimoji="1" lang="en-US" altLang="ja-JP" sz="1013" dirty="0"/>
                <a:t>Da</a:t>
              </a:r>
              <a:endParaRPr kumimoji="1" lang="ja-JP" altLang="en-US" sz="1013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148077" y="5120294"/>
              <a:ext cx="820511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13" dirty="0"/>
                <a:t>20</a:t>
              </a:r>
              <a:r>
                <a:rPr kumimoji="1" lang="ja-JP" altLang="en-US" sz="1013" dirty="0" err="1"/>
                <a:t>ｋ</a:t>
              </a:r>
              <a:r>
                <a:rPr kumimoji="1" lang="en-US" altLang="ja-JP" sz="1013" dirty="0"/>
                <a:t>Da</a:t>
              </a:r>
              <a:endParaRPr kumimoji="1" lang="ja-JP" altLang="en-US" sz="1013" dirty="0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DEF07DF-E9F8-498F-9348-601D96092FA4}"/>
              </a:ext>
            </a:extLst>
          </p:cNvPr>
          <p:cNvSpPr txBox="1"/>
          <p:nvPr/>
        </p:nvSpPr>
        <p:spPr>
          <a:xfrm>
            <a:off x="322471" y="275075"/>
            <a:ext cx="363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Uncropped western blotting</a:t>
            </a:r>
            <a:r>
              <a:rPr kumimoji="1" lang="ja-JP" altLang="en-US" dirty="0"/>
              <a:t> </a:t>
            </a:r>
            <a:r>
              <a:rPr kumimoji="1" lang="en-US" altLang="ja-JP" dirty="0"/>
              <a:t>for Fig5 </a:t>
            </a:r>
            <a:endParaRPr kumimoji="1" lang="ja-JP" altLang="en-US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1754985-F423-4F14-B19E-51AE9C570C35}"/>
              </a:ext>
            </a:extLst>
          </p:cNvPr>
          <p:cNvSpPr txBox="1"/>
          <p:nvPr/>
        </p:nvSpPr>
        <p:spPr>
          <a:xfrm>
            <a:off x="2837363" y="3541054"/>
            <a:ext cx="891675" cy="1895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19" dirty="0"/>
              <a:t>Saline              Vaccine     </a:t>
            </a:r>
            <a:endParaRPr kumimoji="1" lang="ja-JP" altLang="en-US" sz="619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7B8DEFC-6E13-495E-B48C-4D28C2823022}"/>
              </a:ext>
            </a:extLst>
          </p:cNvPr>
          <p:cNvSpPr txBox="1"/>
          <p:nvPr/>
        </p:nvSpPr>
        <p:spPr>
          <a:xfrm>
            <a:off x="3881277" y="3555085"/>
            <a:ext cx="891675" cy="1895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19" dirty="0"/>
              <a:t>Saline              Vaccine     </a:t>
            </a:r>
            <a:endParaRPr kumimoji="1" lang="ja-JP" altLang="en-US" sz="619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76BD389-D657-4D53-8054-7D9C9017E996}"/>
              </a:ext>
            </a:extLst>
          </p:cNvPr>
          <p:cNvSpPr txBox="1"/>
          <p:nvPr/>
        </p:nvSpPr>
        <p:spPr>
          <a:xfrm>
            <a:off x="4925191" y="3531431"/>
            <a:ext cx="891675" cy="1895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19" dirty="0"/>
              <a:t>Saline              Vaccine     </a:t>
            </a:r>
            <a:endParaRPr kumimoji="1" lang="ja-JP" altLang="en-US" sz="619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337630C2-3D05-4F7E-834A-640F00AB19B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84899"/>
            <a:ext cx="6858000" cy="3857625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7457EFF-1B5A-4DE8-8C1E-4BF25191D2F4}"/>
              </a:ext>
            </a:extLst>
          </p:cNvPr>
          <p:cNvSpPr txBox="1"/>
          <p:nvPr/>
        </p:nvSpPr>
        <p:spPr>
          <a:xfrm>
            <a:off x="1322616" y="7065503"/>
            <a:ext cx="69192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13" dirty="0"/>
              <a:t>140kDa</a:t>
            </a:r>
            <a:endParaRPr kumimoji="1" lang="ja-JP" altLang="en-US" sz="1013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D5E9DE4-B11F-4A78-A377-7863673F9A8C}"/>
              </a:ext>
            </a:extLst>
          </p:cNvPr>
          <p:cNvSpPr txBox="1"/>
          <p:nvPr/>
        </p:nvSpPr>
        <p:spPr>
          <a:xfrm>
            <a:off x="1818595" y="7613173"/>
            <a:ext cx="501704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b="1" dirty="0"/>
              <a:t>Saline   Vaccine                     Saline  Vaccine                  Saline  Vaccine                          Saline  Vaccine  </a:t>
            </a:r>
            <a:endParaRPr kumimoji="1" lang="ja-JP" altLang="en-US" sz="8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50D1DFD-4228-413F-9659-129F616885B0}"/>
              </a:ext>
            </a:extLst>
          </p:cNvPr>
          <p:cNvSpPr txBox="1"/>
          <p:nvPr/>
        </p:nvSpPr>
        <p:spPr>
          <a:xfrm>
            <a:off x="924605" y="5934396"/>
            <a:ext cx="500878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/>
              <a:t>Rat</a:t>
            </a:r>
            <a:r>
              <a:rPr kumimoji="1" lang="ja-JP" altLang="en-US" sz="1350" dirty="0"/>
              <a:t>　　</a:t>
            </a:r>
            <a:r>
              <a:rPr kumimoji="1" lang="en-US" altLang="ja-JP" sz="1350" dirty="0" err="1"/>
              <a:t>eNOS</a:t>
            </a:r>
            <a:endParaRPr kumimoji="1" lang="ja-JP" altLang="en-US" sz="135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93156EC-0EAB-4186-95BC-C948E8028F03}"/>
              </a:ext>
            </a:extLst>
          </p:cNvPr>
          <p:cNvSpPr txBox="1"/>
          <p:nvPr/>
        </p:nvSpPr>
        <p:spPr>
          <a:xfrm>
            <a:off x="4785570" y="5587928"/>
            <a:ext cx="1689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13min exposure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8EAE321-4F6C-4B58-8604-09030EBE8958}"/>
              </a:ext>
            </a:extLst>
          </p:cNvPr>
          <p:cNvSpPr txBox="1"/>
          <p:nvPr/>
        </p:nvSpPr>
        <p:spPr>
          <a:xfrm>
            <a:off x="6015517" y="2931178"/>
            <a:ext cx="891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nom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B1EDBA4-100B-4A62-8B31-B33FD89B8A1E}"/>
              </a:ext>
            </a:extLst>
          </p:cNvPr>
          <p:cNvSpPr txBox="1"/>
          <p:nvPr/>
        </p:nvSpPr>
        <p:spPr>
          <a:xfrm>
            <a:off x="5994539" y="2505831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2FE94516-44DD-45DF-912D-303540A8E160}"/>
              </a:ext>
            </a:extLst>
          </p:cNvPr>
          <p:cNvCxnSpPr/>
          <p:nvPr/>
        </p:nvCxnSpPr>
        <p:spPr>
          <a:xfrm flipH="1">
            <a:off x="5743592" y="2662864"/>
            <a:ext cx="31430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461A233F-6B06-45A0-96EE-ED29C3FC8ABC}"/>
              </a:ext>
            </a:extLst>
          </p:cNvPr>
          <p:cNvCxnSpPr/>
          <p:nvPr/>
        </p:nvCxnSpPr>
        <p:spPr>
          <a:xfrm flipH="1">
            <a:off x="5751538" y="3079937"/>
            <a:ext cx="31430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08651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909BF027-FFED-4B34-8AB9-00799E6382C8}"/>
              </a:ext>
            </a:extLst>
          </p:cNvPr>
          <p:cNvGrpSpPr/>
          <p:nvPr/>
        </p:nvGrpSpPr>
        <p:grpSpPr>
          <a:xfrm>
            <a:off x="-28364" y="6038569"/>
            <a:ext cx="6886364" cy="3867431"/>
            <a:chOff x="0" y="10886"/>
            <a:chExt cx="6886364" cy="3867431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07B7FDDE-B5FC-4FDC-AC3D-C3CEF0BFF2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0886"/>
              <a:ext cx="6886364" cy="3867431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EA21C08-009D-42AA-A65C-2FD966ABD3AE}"/>
                </a:ext>
              </a:extLst>
            </p:cNvPr>
            <p:cNvSpPr txBox="1"/>
            <p:nvPr/>
          </p:nvSpPr>
          <p:spPr>
            <a:xfrm>
              <a:off x="1306853" y="1752506"/>
              <a:ext cx="691923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13" dirty="0"/>
                <a:t>140kDa</a:t>
              </a:r>
              <a:endParaRPr kumimoji="1" lang="ja-JP" altLang="en-US" sz="1013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9AF2AF0D-F15F-4194-B87B-917FD8BD2950}"/>
                </a:ext>
              </a:extLst>
            </p:cNvPr>
            <p:cNvSpPr txBox="1"/>
            <p:nvPr/>
          </p:nvSpPr>
          <p:spPr>
            <a:xfrm>
              <a:off x="1802832" y="2300176"/>
              <a:ext cx="501704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800" b="1" dirty="0"/>
                <a:t>Saline   Vaccine                     Saline  Vaccine                  Saline  Vaccine                          Saline  Vaccine  </a:t>
              </a:r>
              <a:endParaRPr kumimoji="1" lang="ja-JP" altLang="en-US" sz="800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22EEFC5-B72C-4ACB-8DC1-6EE2C31DE2FC}"/>
                </a:ext>
              </a:extLst>
            </p:cNvPr>
            <p:cNvSpPr txBox="1"/>
            <p:nvPr/>
          </p:nvSpPr>
          <p:spPr>
            <a:xfrm>
              <a:off x="908842" y="621399"/>
              <a:ext cx="5008789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/>
                <a:t>Rat</a:t>
              </a:r>
              <a:r>
                <a:rPr kumimoji="1" lang="ja-JP" altLang="en-US" sz="1350" dirty="0"/>
                <a:t>　　</a:t>
              </a:r>
              <a:r>
                <a:rPr kumimoji="1" lang="en-US" altLang="ja-JP" sz="1350" dirty="0" err="1"/>
                <a:t>eNOS</a:t>
              </a:r>
              <a:endParaRPr kumimoji="1" lang="ja-JP" altLang="en-US" sz="1350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F5651BD-CAA8-40EB-9B6C-89BFB728C3A4}"/>
                </a:ext>
              </a:extLst>
            </p:cNvPr>
            <p:cNvSpPr txBox="1"/>
            <p:nvPr/>
          </p:nvSpPr>
          <p:spPr>
            <a:xfrm>
              <a:off x="4769807" y="274931"/>
              <a:ext cx="16898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5min exposure</a:t>
              </a:r>
              <a:endParaRPr kumimoji="1" lang="ja-JP" altLang="en-US" dirty="0"/>
            </a:p>
          </p:txBody>
        </p:sp>
      </p:grpSp>
      <p:pic>
        <p:nvPicPr>
          <p:cNvPr id="10" name="図 9">
            <a:extLst>
              <a:ext uri="{FF2B5EF4-FFF2-40B4-BE49-F238E27FC236}">
                <a16:creationId xmlns:a16="http://schemas.microsoft.com/office/drawing/2014/main" id="{C6F290BE-1A90-4AB3-A680-8286E6891B1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886"/>
            <a:ext cx="6866980" cy="3856545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7A66DD7-6753-444B-95D8-A0D1C1429180}"/>
              </a:ext>
            </a:extLst>
          </p:cNvPr>
          <p:cNvSpPr txBox="1"/>
          <p:nvPr/>
        </p:nvSpPr>
        <p:spPr>
          <a:xfrm>
            <a:off x="1228018" y="1689450"/>
            <a:ext cx="69192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13" dirty="0"/>
              <a:t>140kDa</a:t>
            </a:r>
            <a:endParaRPr kumimoji="1" lang="ja-JP" altLang="en-US" sz="1013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751945A-F70F-4C06-8488-924A819DA86B}"/>
              </a:ext>
            </a:extLst>
          </p:cNvPr>
          <p:cNvSpPr txBox="1"/>
          <p:nvPr/>
        </p:nvSpPr>
        <p:spPr>
          <a:xfrm>
            <a:off x="1723997" y="2237120"/>
            <a:ext cx="501704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b="1" dirty="0"/>
              <a:t>Saline   Vaccine                     Saline  Vaccine                  Saline  Vaccine                          Saline  Vaccine  </a:t>
            </a:r>
            <a:endParaRPr kumimoji="1" lang="ja-JP" altLang="en-US" sz="8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BCF6FE3-10B5-4E8A-A77E-5065B198C330}"/>
              </a:ext>
            </a:extLst>
          </p:cNvPr>
          <p:cNvSpPr txBox="1"/>
          <p:nvPr/>
        </p:nvSpPr>
        <p:spPr>
          <a:xfrm>
            <a:off x="830007" y="558343"/>
            <a:ext cx="500878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/>
              <a:t>Rat</a:t>
            </a:r>
            <a:r>
              <a:rPr kumimoji="1" lang="ja-JP" altLang="en-US" sz="1350" dirty="0"/>
              <a:t>　　</a:t>
            </a:r>
            <a:r>
              <a:rPr kumimoji="1" lang="en-US" altLang="ja-JP" sz="1350" dirty="0" err="1"/>
              <a:t>eNOS</a:t>
            </a:r>
            <a:endParaRPr kumimoji="1" lang="ja-JP" altLang="en-US" sz="135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AB390BF-643D-45C5-B280-3D797461CF71}"/>
              </a:ext>
            </a:extLst>
          </p:cNvPr>
          <p:cNvSpPr txBox="1"/>
          <p:nvPr/>
        </p:nvSpPr>
        <p:spPr>
          <a:xfrm>
            <a:off x="4690972" y="211875"/>
            <a:ext cx="1742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19 min exposure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244843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F91E21F-FB49-4F84-A4D2-FE5E8A7C282D}"/>
              </a:ext>
            </a:extLst>
          </p:cNvPr>
          <p:cNvSpPr txBox="1"/>
          <p:nvPr/>
        </p:nvSpPr>
        <p:spPr>
          <a:xfrm>
            <a:off x="126526" y="248565"/>
            <a:ext cx="363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Uncropped western blotting</a:t>
            </a:r>
            <a:r>
              <a:rPr kumimoji="1" lang="ja-JP" altLang="en-US" dirty="0"/>
              <a:t> </a:t>
            </a:r>
            <a:r>
              <a:rPr kumimoji="1" lang="en-US" altLang="ja-JP" dirty="0"/>
              <a:t>for Fig5 </a:t>
            </a:r>
            <a:endParaRPr kumimoji="1" lang="ja-JP" altLang="en-US" dirty="0"/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7309EC64-2365-47CC-9E04-21BB994CEA15}"/>
              </a:ext>
            </a:extLst>
          </p:cNvPr>
          <p:cNvGrpSpPr/>
          <p:nvPr/>
        </p:nvGrpSpPr>
        <p:grpSpPr>
          <a:xfrm>
            <a:off x="0" y="928576"/>
            <a:ext cx="6858000" cy="3857625"/>
            <a:chOff x="0" y="3024187"/>
            <a:chExt cx="6858000" cy="3857625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D25CA01C-53A6-47CD-B1E2-0AEBFE9A76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024187"/>
              <a:ext cx="6858000" cy="3857625"/>
            </a:xfrm>
            <a:prstGeom prst="rect">
              <a:avLst/>
            </a:prstGeom>
          </p:spPr>
        </p:pic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28B834E8-2F34-4187-88B8-78338525C859}"/>
                </a:ext>
              </a:extLst>
            </p:cNvPr>
            <p:cNvSpPr txBox="1"/>
            <p:nvPr/>
          </p:nvSpPr>
          <p:spPr>
            <a:xfrm>
              <a:off x="1187903" y="3863069"/>
              <a:ext cx="514962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350" dirty="0">
                  <a:latin typeface="HGPｺﾞｼｯｸE" panose="020B0900000000000000" pitchFamily="50" charset="-128"/>
                  <a:ea typeface="HGPｺﾞｼｯｸE" panose="020B0900000000000000" pitchFamily="50" charset="-128"/>
                </a:rPr>
                <a:t>βactin</a:t>
              </a:r>
              <a:endParaRPr kumimoji="1" lang="ja-JP" altLang="en-US" sz="1350" dirty="0">
                <a:latin typeface="HGPｺﾞｼｯｸE" panose="020B0900000000000000" pitchFamily="50" charset="-128"/>
                <a:ea typeface="HGPｺﾞｼｯｸE" panose="020B0900000000000000" pitchFamily="50" charset="-128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3B3E6094-F5B7-4F0F-A7B2-02BE9080FB1D}"/>
                </a:ext>
              </a:extLst>
            </p:cNvPr>
            <p:cNvSpPr txBox="1"/>
            <p:nvPr/>
          </p:nvSpPr>
          <p:spPr>
            <a:xfrm>
              <a:off x="979715" y="4652963"/>
              <a:ext cx="52659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13" dirty="0"/>
                <a:t>50kDa</a:t>
              </a:r>
              <a:endParaRPr kumimoji="1" lang="ja-JP" altLang="en-US" sz="1013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B1E8A9DA-873D-452E-BA71-F184C505A03E}"/>
                </a:ext>
              </a:extLst>
            </p:cNvPr>
            <p:cNvSpPr txBox="1"/>
            <p:nvPr/>
          </p:nvSpPr>
          <p:spPr>
            <a:xfrm>
              <a:off x="979715" y="4933407"/>
              <a:ext cx="52659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13" dirty="0"/>
                <a:t>37kDa</a:t>
              </a:r>
              <a:endParaRPr kumimoji="1" lang="ja-JP" altLang="en-US" sz="1013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F0C06A94-F084-465B-927A-9CF9CB31ADD7}"/>
                </a:ext>
              </a:extLst>
            </p:cNvPr>
            <p:cNvSpPr txBox="1"/>
            <p:nvPr/>
          </p:nvSpPr>
          <p:spPr>
            <a:xfrm>
              <a:off x="1840960" y="5414759"/>
              <a:ext cx="501704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800" b="1" dirty="0"/>
                <a:t>Saline   Vaccine                     Saline  Vaccine                  Saline  Vaccine                          Saline  Vaccine  </a:t>
              </a:r>
              <a:endParaRPr kumimoji="1" lang="ja-JP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9001396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C958D4B-91F6-4DB7-A246-E802E4D8C6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68" t="-3303" r="534" b="252"/>
          <a:stretch/>
        </p:blipFill>
        <p:spPr>
          <a:xfrm>
            <a:off x="1" y="5051503"/>
            <a:ext cx="6858000" cy="398605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928B436-61DD-42D9-ADF2-6310607F686B}"/>
              </a:ext>
            </a:extLst>
          </p:cNvPr>
          <p:cNvSpPr txBox="1"/>
          <p:nvPr/>
        </p:nvSpPr>
        <p:spPr>
          <a:xfrm>
            <a:off x="253560" y="129245"/>
            <a:ext cx="5556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Uncropped western blotting</a:t>
            </a:r>
            <a:r>
              <a:rPr kumimoji="1" lang="ja-JP" altLang="en-US" dirty="0"/>
              <a:t> </a:t>
            </a:r>
            <a:r>
              <a:rPr kumimoji="1" lang="en-US" altLang="ja-JP" dirty="0"/>
              <a:t>for supplementary figure 3b </a:t>
            </a:r>
            <a:endParaRPr kumimoji="1" lang="ja-JP" altLang="en-US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336AD68-FF2B-4AD0-BD9B-3199A29B702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75" t="-910" r="-4661" b="-2147"/>
          <a:stretch/>
        </p:blipFill>
        <p:spPr>
          <a:xfrm>
            <a:off x="-81419" y="919620"/>
            <a:ext cx="7265096" cy="39822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4AE445D-2E32-4DA0-832C-09627DA11593}"/>
              </a:ext>
            </a:extLst>
          </p:cNvPr>
          <p:cNvSpPr txBox="1"/>
          <p:nvPr/>
        </p:nvSpPr>
        <p:spPr>
          <a:xfrm>
            <a:off x="1206692" y="216070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sEH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E3B05E1-B819-48A0-94F6-2EF6441A1F4C}"/>
              </a:ext>
            </a:extLst>
          </p:cNvPr>
          <p:cNvSpPr txBox="1"/>
          <p:nvPr/>
        </p:nvSpPr>
        <p:spPr>
          <a:xfrm>
            <a:off x="1272366" y="3540473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D549123-F418-4D6B-9369-80D9C4380A21}"/>
              </a:ext>
            </a:extLst>
          </p:cNvPr>
          <p:cNvSpPr txBox="1"/>
          <p:nvPr/>
        </p:nvSpPr>
        <p:spPr>
          <a:xfrm>
            <a:off x="2065732" y="3540473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538B7A6-8E41-452A-9D43-7B5DBADFAE56}"/>
              </a:ext>
            </a:extLst>
          </p:cNvPr>
          <p:cNvSpPr txBox="1"/>
          <p:nvPr/>
        </p:nvSpPr>
        <p:spPr>
          <a:xfrm>
            <a:off x="3143519" y="3540473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569EF28-B053-49F7-B441-DA7267ED0CE2}"/>
              </a:ext>
            </a:extLst>
          </p:cNvPr>
          <p:cNvSpPr txBox="1"/>
          <p:nvPr/>
        </p:nvSpPr>
        <p:spPr>
          <a:xfrm>
            <a:off x="3886026" y="3540473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CFD599A-1D04-43B8-8091-97B6C0A06254}"/>
              </a:ext>
            </a:extLst>
          </p:cNvPr>
          <p:cNvSpPr txBox="1"/>
          <p:nvPr/>
        </p:nvSpPr>
        <p:spPr>
          <a:xfrm>
            <a:off x="4975686" y="3540473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105DD8-4E15-4129-9AD2-5F6111818AD5}"/>
              </a:ext>
            </a:extLst>
          </p:cNvPr>
          <p:cNvSpPr txBox="1"/>
          <p:nvPr/>
        </p:nvSpPr>
        <p:spPr>
          <a:xfrm>
            <a:off x="854188" y="6166044"/>
            <a:ext cx="51496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latin typeface="HGPｺﾞｼｯｸE" panose="020B0900000000000000" pitchFamily="50" charset="-128"/>
                <a:ea typeface="HGPｺﾞｼｯｸE" panose="020B0900000000000000" pitchFamily="50" charset="-128"/>
              </a:rPr>
              <a:t>βactin</a:t>
            </a:r>
            <a:endParaRPr kumimoji="1" lang="ja-JP" altLang="en-US" sz="1350" dirty="0">
              <a:latin typeface="HGPｺﾞｼｯｸE" panose="020B0900000000000000" pitchFamily="50" charset="-128"/>
              <a:ea typeface="HGPｺﾞｼｯｸE" panose="020B0900000000000000" pitchFamily="50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ECA513-CE23-4D61-86AD-128195BC9122}"/>
              </a:ext>
            </a:extLst>
          </p:cNvPr>
          <p:cNvSpPr txBox="1"/>
          <p:nvPr/>
        </p:nvSpPr>
        <p:spPr>
          <a:xfrm>
            <a:off x="1803195" y="7428267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F0F3DDE-7500-498B-84E3-A65DCE08D58B}"/>
              </a:ext>
            </a:extLst>
          </p:cNvPr>
          <p:cNvSpPr txBox="1"/>
          <p:nvPr/>
        </p:nvSpPr>
        <p:spPr>
          <a:xfrm>
            <a:off x="2596561" y="7428267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F84C8E4-DB15-4410-BD7D-CA98B913A375}"/>
              </a:ext>
            </a:extLst>
          </p:cNvPr>
          <p:cNvSpPr txBox="1"/>
          <p:nvPr/>
        </p:nvSpPr>
        <p:spPr>
          <a:xfrm>
            <a:off x="3674348" y="7428267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B651F5-77FD-4C75-B8BA-C75A094B2F99}"/>
              </a:ext>
            </a:extLst>
          </p:cNvPr>
          <p:cNvSpPr txBox="1"/>
          <p:nvPr/>
        </p:nvSpPr>
        <p:spPr>
          <a:xfrm>
            <a:off x="4416855" y="7428267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DB50F97-43B5-4E90-ADDF-09935F50A518}"/>
              </a:ext>
            </a:extLst>
          </p:cNvPr>
          <p:cNvSpPr txBox="1"/>
          <p:nvPr/>
        </p:nvSpPr>
        <p:spPr>
          <a:xfrm>
            <a:off x="5506515" y="7428267"/>
            <a:ext cx="793366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4860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9</TotalTime>
  <Words>734</Words>
  <Application>Microsoft Office PowerPoint</Application>
  <PresentationFormat>A4 210 x 297 mm</PresentationFormat>
  <Paragraphs>110</Paragraphs>
  <Slides>8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HGPｺﾞｼｯｸE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白木　綾</dc:creator>
  <cp:lastModifiedBy>白木　綾</cp:lastModifiedBy>
  <cp:revision>63</cp:revision>
  <cp:lastPrinted>2021-05-11T04:45:21Z</cp:lastPrinted>
  <dcterms:created xsi:type="dcterms:W3CDTF">2021-03-08T06:22:27Z</dcterms:created>
  <dcterms:modified xsi:type="dcterms:W3CDTF">2022-02-14T00:36:11Z</dcterms:modified>
</cp:coreProperties>
</file>